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0" r:id="rId2"/>
    <p:sldId id="261" r:id="rId3"/>
  </p:sldIdLst>
  <p:sldSz cx="12192000" cy="6858000"/>
  <p:notesSz cx="6858000" cy="9144000"/>
  <p:custDataLst>
    <p:tags r:id="rId4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738" autoAdjust="0"/>
    <p:restoredTop sz="94660"/>
  </p:normalViewPr>
  <p:slideViewPr>
    <p:cSldViewPr snapToGrid="0">
      <p:cViewPr varScale="1">
        <p:scale>
          <a:sx n="110" d="100"/>
          <a:sy n="110" d="100"/>
        </p:scale>
        <p:origin x="30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tags" Target="tags/tag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4C6C4F-F128-4E4E-A35E-6FB71CFA0C5B}" type="datetimeFigureOut">
              <a:rPr lang="zh-CN" altLang="en-US" smtClean="0"/>
              <a:t>2024/1/18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1B15A0-DDE0-41E0-B465-4E7A2288D849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4309144" y="4401998"/>
            <a:ext cx="6948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  <a:r>
              <a:rPr lang="en-US" altLang="zh-CN" sz="1800" dirty="0"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 Relationship between all mutations and NUP98 fusions in the 55 NUP98r leukemia patients.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8081" y="0"/>
            <a:ext cx="3067050" cy="68580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文本框 5"/>
          <p:cNvSpPr txBox="1"/>
          <p:nvPr/>
        </p:nvSpPr>
        <p:spPr>
          <a:xfrm>
            <a:off x="1104549" y="5855516"/>
            <a:ext cx="78739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 The </a:t>
            </a:r>
            <a:r>
              <a:rPr lang="en-US" altLang="zh-CN" sz="18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VAF of different mutations and positive patients number.</a:t>
            </a:r>
            <a:endParaRPr lang="zh-CN" altLang="zh-CN" sz="1800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2732" y="-2097"/>
            <a:ext cx="9525000" cy="5715000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zY1YWI2MTNiZTQ5OWViMjc4MmU2ZGJiNzgxN2QxN2UifQ==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0</Words>
  <Application>Microsoft Office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7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ina jie</dc:creator>
  <cp:lastModifiedBy>Sujiang Zhang</cp:lastModifiedBy>
  <cp:revision>25</cp:revision>
  <dcterms:created xsi:type="dcterms:W3CDTF">2023-12-18T11:27:00Z</dcterms:created>
  <dcterms:modified xsi:type="dcterms:W3CDTF">2024-01-18T01:17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2B3093BFF9CA47BC89AC0A08CC6A4331_12</vt:lpwstr>
  </property>
  <property fmtid="{D5CDD505-2E9C-101B-9397-08002B2CF9AE}" pid="3" name="KSOProductBuildVer">
    <vt:lpwstr>2052-12.1.0.16120</vt:lpwstr>
  </property>
</Properties>
</file>